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>
        <p:scale>
          <a:sx n="69" d="100"/>
          <a:sy n="69" d="100"/>
        </p:scale>
        <p:origin x="3348" y="22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1FB04-1000-40EB-B142-D77191A953B1}" type="datetimeFigureOut">
              <a:rPr lang="en-US" smtClean="0"/>
              <a:t>10/1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28F4F9-825C-461D-9D13-A8B983CAD6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67076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1FB04-1000-40EB-B142-D77191A953B1}" type="datetimeFigureOut">
              <a:rPr lang="en-US" smtClean="0"/>
              <a:t>10/1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28F4F9-825C-461D-9D13-A8B983CAD6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15145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1FB04-1000-40EB-B142-D77191A953B1}" type="datetimeFigureOut">
              <a:rPr lang="en-US" smtClean="0"/>
              <a:t>10/1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28F4F9-825C-461D-9D13-A8B983CAD6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22864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1FB04-1000-40EB-B142-D77191A953B1}" type="datetimeFigureOut">
              <a:rPr lang="en-US" smtClean="0"/>
              <a:t>10/1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28F4F9-825C-461D-9D13-A8B983CAD6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79066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1FB04-1000-40EB-B142-D77191A953B1}" type="datetimeFigureOut">
              <a:rPr lang="en-US" smtClean="0"/>
              <a:t>10/1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28F4F9-825C-461D-9D13-A8B983CAD6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24080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1FB04-1000-40EB-B142-D77191A953B1}" type="datetimeFigureOut">
              <a:rPr lang="en-US" smtClean="0"/>
              <a:t>10/1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28F4F9-825C-461D-9D13-A8B983CAD6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33276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1FB04-1000-40EB-B142-D77191A953B1}" type="datetimeFigureOut">
              <a:rPr lang="en-US" smtClean="0"/>
              <a:t>10/13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28F4F9-825C-461D-9D13-A8B983CAD6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15190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1FB04-1000-40EB-B142-D77191A953B1}" type="datetimeFigureOut">
              <a:rPr lang="en-US" smtClean="0"/>
              <a:t>10/13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28F4F9-825C-461D-9D13-A8B983CAD6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78254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1FB04-1000-40EB-B142-D77191A953B1}" type="datetimeFigureOut">
              <a:rPr lang="en-US" smtClean="0"/>
              <a:t>10/13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28F4F9-825C-461D-9D13-A8B983CAD6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25418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1FB04-1000-40EB-B142-D77191A953B1}" type="datetimeFigureOut">
              <a:rPr lang="en-US" smtClean="0"/>
              <a:t>10/1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28F4F9-825C-461D-9D13-A8B983CAD6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11428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1FB04-1000-40EB-B142-D77191A953B1}" type="datetimeFigureOut">
              <a:rPr lang="en-US" smtClean="0"/>
              <a:t>10/1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28F4F9-825C-461D-9D13-A8B983CAD6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72986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651FB04-1000-40EB-B142-D77191A953B1}" type="datetimeFigureOut">
              <a:rPr lang="en-US" smtClean="0"/>
              <a:t>10/1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428F4F9-825C-461D-9D13-A8B983CAD6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57137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1" name="Picture 120">
            <a:extLst>
              <a:ext uri="{FF2B5EF4-FFF2-40B4-BE49-F238E27FC236}">
                <a16:creationId xmlns:a16="http://schemas.microsoft.com/office/drawing/2014/main" id="{D5F55D44-E046-2FDB-11E8-52CDF877BD8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12879" y="2397216"/>
            <a:ext cx="2352675" cy="2381250"/>
          </a:xfrm>
          <a:prstGeom prst="rect">
            <a:avLst/>
          </a:prstGeom>
        </p:spPr>
      </p:pic>
      <p:pic>
        <p:nvPicPr>
          <p:cNvPr id="122" name="Picture 121">
            <a:extLst>
              <a:ext uri="{FF2B5EF4-FFF2-40B4-BE49-F238E27FC236}">
                <a16:creationId xmlns:a16="http://schemas.microsoft.com/office/drawing/2014/main" id="{8D7EF511-E8F3-776D-67F3-1B44AC08E9F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80200" y="127757"/>
            <a:ext cx="3052204" cy="1885185"/>
          </a:xfrm>
          <a:prstGeom prst="rect">
            <a:avLst/>
          </a:prstGeom>
        </p:spPr>
      </p:pic>
      <p:pic>
        <p:nvPicPr>
          <p:cNvPr id="123" name="Picture 122">
            <a:extLst>
              <a:ext uri="{FF2B5EF4-FFF2-40B4-BE49-F238E27FC236}">
                <a16:creationId xmlns:a16="http://schemas.microsoft.com/office/drawing/2014/main" id="{F6FC9D7F-A1BF-F0EF-1EEA-D7E3559AA95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076022" y="1731833"/>
            <a:ext cx="3267908" cy="2234860"/>
          </a:xfrm>
          <a:prstGeom prst="rect">
            <a:avLst/>
          </a:prstGeom>
        </p:spPr>
      </p:pic>
      <p:pic>
        <p:nvPicPr>
          <p:cNvPr id="124" name="Picture 123">
            <a:extLst>
              <a:ext uri="{FF2B5EF4-FFF2-40B4-BE49-F238E27FC236}">
                <a16:creationId xmlns:a16="http://schemas.microsoft.com/office/drawing/2014/main" id="{BA95A98C-EF1C-2104-B312-D912CD05E20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29000" y="3966693"/>
            <a:ext cx="3052204" cy="2366907"/>
          </a:xfrm>
          <a:prstGeom prst="rect">
            <a:avLst/>
          </a:prstGeom>
        </p:spPr>
      </p:pic>
      <p:pic>
        <p:nvPicPr>
          <p:cNvPr id="125" name="Picture 124">
            <a:extLst>
              <a:ext uri="{FF2B5EF4-FFF2-40B4-BE49-F238E27FC236}">
                <a16:creationId xmlns:a16="http://schemas.microsoft.com/office/drawing/2014/main" id="{8EB9A570-772A-A390-999A-061DAAF66B3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580200" y="7869817"/>
            <a:ext cx="3045351" cy="1750520"/>
          </a:xfrm>
          <a:prstGeom prst="rect">
            <a:avLst/>
          </a:prstGeom>
        </p:spPr>
      </p:pic>
      <p:pic>
        <p:nvPicPr>
          <p:cNvPr id="127" name="Picture 126">
            <a:extLst>
              <a:ext uri="{FF2B5EF4-FFF2-40B4-BE49-F238E27FC236}">
                <a16:creationId xmlns:a16="http://schemas.microsoft.com/office/drawing/2014/main" id="{CA8CEECD-1E7A-6AD4-BEB4-5D3C58E8327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642547" y="5920444"/>
            <a:ext cx="2701383" cy="1833274"/>
          </a:xfrm>
          <a:prstGeom prst="rect">
            <a:avLst/>
          </a:prstGeom>
        </p:spPr>
      </p:pic>
      <p:sp>
        <p:nvSpPr>
          <p:cNvPr id="128" name="TextBox 127">
            <a:extLst>
              <a:ext uri="{FF2B5EF4-FFF2-40B4-BE49-F238E27FC236}">
                <a16:creationId xmlns:a16="http://schemas.microsoft.com/office/drawing/2014/main" id="{CB6FD840-8BC7-3DF9-0C6D-E30931ED8C64}"/>
              </a:ext>
            </a:extLst>
          </p:cNvPr>
          <p:cNvSpPr txBox="1"/>
          <p:nvPr/>
        </p:nvSpPr>
        <p:spPr>
          <a:xfrm>
            <a:off x="3580200" y="426443"/>
            <a:ext cx="166809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HA-GST</a:t>
            </a:r>
          </a:p>
          <a:p>
            <a:r>
              <a:rPr lang="en-US" sz="1000" dirty="0"/>
              <a:t>HA-GST K151R</a:t>
            </a:r>
          </a:p>
          <a:p>
            <a:r>
              <a:rPr lang="en-US" sz="1000" dirty="0"/>
              <a:t>SIRT2 KD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5EB01366-5343-F439-2D9E-3CB14D607058}"/>
              </a:ext>
            </a:extLst>
          </p:cNvPr>
          <p:cNvSpPr txBox="1"/>
          <p:nvPr/>
        </p:nvSpPr>
        <p:spPr>
          <a:xfrm>
            <a:off x="4621815" y="413319"/>
            <a:ext cx="253596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+</a:t>
            </a:r>
          </a:p>
          <a:p>
            <a:r>
              <a:rPr lang="en-US" sz="1000" dirty="0"/>
              <a:t>-</a:t>
            </a:r>
          </a:p>
          <a:p>
            <a:r>
              <a:rPr lang="en-US" sz="1000" dirty="0"/>
              <a:t>+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A011057E-58E9-7DCF-072A-F146549F8102}"/>
              </a:ext>
            </a:extLst>
          </p:cNvPr>
          <p:cNvSpPr txBox="1"/>
          <p:nvPr/>
        </p:nvSpPr>
        <p:spPr>
          <a:xfrm>
            <a:off x="4893967" y="413564"/>
            <a:ext cx="253596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-</a:t>
            </a:r>
          </a:p>
          <a:p>
            <a:r>
              <a:rPr lang="en-US" sz="1000" dirty="0"/>
              <a:t>+</a:t>
            </a:r>
          </a:p>
          <a:p>
            <a:r>
              <a:rPr lang="en-US" sz="1000" dirty="0"/>
              <a:t>+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11616BD7-7D54-7475-9799-E5B61A8E0EBA}"/>
              </a:ext>
            </a:extLst>
          </p:cNvPr>
          <p:cNvSpPr txBox="1"/>
          <p:nvPr/>
        </p:nvSpPr>
        <p:spPr>
          <a:xfrm>
            <a:off x="3085897" y="1321168"/>
            <a:ext cx="4844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A IP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CDFB7C58-ACC0-2992-FBF9-47373C478B71}"/>
              </a:ext>
            </a:extLst>
          </p:cNvPr>
          <p:cNvSpPr txBox="1"/>
          <p:nvPr/>
        </p:nvSpPr>
        <p:spPr>
          <a:xfrm>
            <a:off x="3150602" y="3109670"/>
            <a:ext cx="3994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KAc</a:t>
            </a:r>
            <a:endParaRPr lang="en-US" sz="1000" dirty="0"/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64191BC7-554E-7069-B34A-3343DC748AB0}"/>
              </a:ext>
            </a:extLst>
          </p:cNvPr>
          <p:cNvSpPr txBox="1"/>
          <p:nvPr/>
        </p:nvSpPr>
        <p:spPr>
          <a:xfrm>
            <a:off x="3186786" y="4829889"/>
            <a:ext cx="3433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Ub</a:t>
            </a: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31B81D94-B7C6-8E00-5A0B-20AEA56281C4}"/>
              </a:ext>
            </a:extLst>
          </p:cNvPr>
          <p:cNvSpPr txBox="1"/>
          <p:nvPr/>
        </p:nvSpPr>
        <p:spPr>
          <a:xfrm>
            <a:off x="2908388" y="6713970"/>
            <a:ext cx="6671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A Input</a:t>
            </a: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9E86BF53-5A4D-FEF5-0334-D7B41EB287BE}"/>
              </a:ext>
            </a:extLst>
          </p:cNvPr>
          <p:cNvSpPr txBox="1"/>
          <p:nvPr/>
        </p:nvSpPr>
        <p:spPr>
          <a:xfrm>
            <a:off x="2883214" y="8461721"/>
            <a:ext cx="8723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SP90 Input</a:t>
            </a:r>
          </a:p>
        </p:txBody>
      </p:sp>
      <p:cxnSp>
        <p:nvCxnSpPr>
          <p:cNvPr id="138" name="Straight Arrow Connector 137">
            <a:extLst>
              <a:ext uri="{FF2B5EF4-FFF2-40B4-BE49-F238E27FC236}">
                <a16:creationId xmlns:a16="http://schemas.microsoft.com/office/drawing/2014/main" id="{13D685FB-302F-23EE-7D54-CCA01849E2E1}"/>
              </a:ext>
            </a:extLst>
          </p:cNvPr>
          <p:cNvCxnSpPr>
            <a:cxnSpLocks/>
          </p:cNvCxnSpPr>
          <p:nvPr/>
        </p:nvCxnSpPr>
        <p:spPr>
          <a:xfrm flipH="1">
            <a:off x="5107610" y="3207142"/>
            <a:ext cx="14068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741687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D548B5CB-2A69-B0A3-4D2B-5E9B3B5AA473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6765"/>
          <a:stretch>
            <a:fillRect/>
          </a:stretch>
        </p:blipFill>
        <p:spPr>
          <a:xfrm>
            <a:off x="0" y="2508539"/>
            <a:ext cx="2545102" cy="2444461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5CE25F46-F812-344B-588D-4FCE63029C4F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7601" b="21363"/>
          <a:stretch>
            <a:fillRect/>
          </a:stretch>
        </p:blipFill>
        <p:spPr>
          <a:xfrm>
            <a:off x="3771835" y="110840"/>
            <a:ext cx="2905386" cy="1634833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DBD1505C-5455-3CBD-17F6-3F434FC28986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t="23730" b="17857"/>
          <a:stretch>
            <a:fillRect/>
          </a:stretch>
        </p:blipFill>
        <p:spPr>
          <a:xfrm>
            <a:off x="3771835" y="1852247"/>
            <a:ext cx="2905386" cy="1312584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ED18D86C-F8E9-3EE5-121B-847D1586A0C8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t="14587" b="25287"/>
          <a:stretch>
            <a:fillRect/>
          </a:stretch>
        </p:blipFill>
        <p:spPr>
          <a:xfrm>
            <a:off x="4003480" y="3560566"/>
            <a:ext cx="2794939" cy="1312584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7016AC47-79F2-4819-85CA-E5343F3C7D94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t="4287" r="6833" b="20554"/>
          <a:stretch>
            <a:fillRect/>
          </a:stretch>
        </p:blipFill>
        <p:spPr>
          <a:xfrm>
            <a:off x="3764082" y="5032851"/>
            <a:ext cx="2913139" cy="1634833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1A21A8FB-40B6-AE0F-B77B-00DCA43A609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072756" y="6827385"/>
            <a:ext cx="2450470" cy="1222164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1E064A65-9FBE-3582-178A-202BBCD4A3D9}"/>
              </a:ext>
            </a:extLst>
          </p:cNvPr>
          <p:cNvSpPr txBox="1"/>
          <p:nvPr/>
        </p:nvSpPr>
        <p:spPr>
          <a:xfrm>
            <a:off x="3222650" y="805145"/>
            <a:ext cx="4844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A IP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802B15B-762D-4E45-471E-6C54C3A45675}"/>
              </a:ext>
            </a:extLst>
          </p:cNvPr>
          <p:cNvSpPr txBox="1"/>
          <p:nvPr/>
        </p:nvSpPr>
        <p:spPr>
          <a:xfrm>
            <a:off x="3058341" y="5727156"/>
            <a:ext cx="8130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IRT2 Input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A9FB7C0-F422-1AC1-637E-F670F109D31D}"/>
              </a:ext>
            </a:extLst>
          </p:cNvPr>
          <p:cNvSpPr txBox="1"/>
          <p:nvPr/>
        </p:nvSpPr>
        <p:spPr>
          <a:xfrm>
            <a:off x="3222650" y="2385428"/>
            <a:ext cx="3433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Ub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8503C0C-E305-8A6D-099E-CA0D4EACFB88}"/>
              </a:ext>
            </a:extLst>
          </p:cNvPr>
          <p:cNvSpPr txBox="1"/>
          <p:nvPr/>
        </p:nvSpPr>
        <p:spPr>
          <a:xfrm>
            <a:off x="3088399" y="4093747"/>
            <a:ext cx="6671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A Input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4A973B7-B70A-AED0-9348-5F784BA215B2}"/>
              </a:ext>
            </a:extLst>
          </p:cNvPr>
          <p:cNvSpPr txBox="1"/>
          <p:nvPr/>
        </p:nvSpPr>
        <p:spPr>
          <a:xfrm>
            <a:off x="3028686" y="7192246"/>
            <a:ext cx="8723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SP90 Input</a:t>
            </a:r>
          </a:p>
        </p:txBody>
      </p:sp>
    </p:spTree>
    <p:extLst>
      <p:ext uri="{BB962C8B-B14F-4D97-AF65-F5344CB8AC3E}">
        <p14:creationId xmlns:p14="http://schemas.microsoft.com/office/powerpoint/2010/main" val="24763034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0</TotalTime>
  <Words>28</Words>
  <Application>Microsoft Office PowerPoint</Application>
  <PresentationFormat>A4 Paper (210x297 mm)</PresentationFormat>
  <Paragraphs>19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marjeet Shrama</dc:creator>
  <cp:lastModifiedBy>Amarjeet Shrama</cp:lastModifiedBy>
  <cp:revision>1</cp:revision>
  <dcterms:created xsi:type="dcterms:W3CDTF">2025-10-13T21:54:54Z</dcterms:created>
  <dcterms:modified xsi:type="dcterms:W3CDTF">2025-10-14T04:15:54Z</dcterms:modified>
</cp:coreProperties>
</file>